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358" r:id="rId2"/>
    <p:sldId id="368" r:id="rId3"/>
    <p:sldId id="359" r:id="rId4"/>
    <p:sldId id="313" r:id="rId5"/>
    <p:sldId id="314" r:id="rId6"/>
    <p:sldId id="351" r:id="rId7"/>
    <p:sldId id="316" r:id="rId8"/>
    <p:sldId id="317" r:id="rId9"/>
    <p:sldId id="318" r:id="rId10"/>
    <p:sldId id="319" r:id="rId11"/>
    <p:sldId id="321" r:id="rId12"/>
  </p:sldIdLst>
  <p:sldSz cx="12192000" cy="6858000"/>
  <p:notesSz cx="6858000" cy="9144000"/>
  <p:custDataLst>
    <p:tags r:id="rId13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309" autoAdjust="0"/>
    <p:restoredTop sz="94660"/>
  </p:normalViewPr>
  <p:slideViewPr>
    <p:cSldViewPr snapToGrid="0">
      <p:cViewPr varScale="1">
        <p:scale>
          <a:sx n="118" d="100"/>
          <a:sy n="118" d="100"/>
        </p:scale>
        <p:origin x="75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gs" Target="tags/tag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C24FC-4F05-46FD-9EC5-4CFE2537F705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1C43E-3378-49DA-AEB3-B40420FBD7F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C24FC-4F05-46FD-9EC5-4CFE2537F705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1C43E-3378-49DA-AEB3-B40420FBD7F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C24FC-4F05-46FD-9EC5-4CFE2537F705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1C43E-3378-49DA-AEB3-B40420FBD7F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C24FC-4F05-46FD-9EC5-4CFE2537F705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1C43E-3378-49DA-AEB3-B40420FBD7F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C24FC-4F05-46FD-9EC5-4CFE2537F705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1C43E-3378-49DA-AEB3-B40420FBD7F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C24FC-4F05-46FD-9EC5-4CFE2537F705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1C43E-3378-49DA-AEB3-B40420FBD7F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C24FC-4F05-46FD-9EC5-4CFE2537F705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1C43E-3378-49DA-AEB3-B40420FBD7F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C24FC-4F05-46FD-9EC5-4CFE2537F705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1C43E-3378-49DA-AEB3-B40420FBD7F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C24FC-4F05-46FD-9EC5-4CFE2537F705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1C43E-3378-49DA-AEB3-B40420FBD7F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C24FC-4F05-46FD-9EC5-4CFE2537F705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1C43E-3378-49DA-AEB3-B40420FBD7F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F9C24FC-4F05-46FD-9EC5-4CFE2537F705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1C43E-3378-49DA-AEB3-B40420FBD7F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9C24FC-4F05-46FD-9EC5-4CFE2537F705}" type="datetimeFigureOut">
              <a:rPr lang="zh-CN" altLang="en-US" smtClean="0"/>
              <a:t>2023/6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D1C43E-3378-49DA-AEB3-B40420FBD7F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1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1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tags" Target="../tags/tag3.xml"/><Relationship Id="rId1" Type="http://schemas.openxmlformats.org/officeDocument/2006/relationships/tags" Target="../tags/tag2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4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5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8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9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tags" Target="../tags/tag10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对象 5"/>
          <p:cNvGraphicFramePr>
            <a:graphicFrameLocks noChangeAspect="1"/>
          </p:cNvGraphicFramePr>
          <p:nvPr/>
        </p:nvGraphicFramePr>
        <p:xfrm>
          <a:off x="1633538" y="1535113"/>
          <a:ext cx="8823325" cy="3646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2" imgW="10220325" imgH="4514850" progId="Prism8.Document">
                  <p:embed/>
                </p:oleObj>
              </mc:Choice>
              <mc:Fallback>
                <p:oleObj name="Prism 8" r:id="rId2" imgW="10220325" imgH="4514850" progId="Prism8.Document">
                  <p:embed/>
                  <p:pic>
                    <p:nvPicPr>
                      <p:cNvPr id="0" name="对象 30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633538" y="1535113"/>
                        <a:ext cx="8823325" cy="3646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2964815" y="5108575"/>
            <a:ext cx="6781800" cy="30670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just"/>
            <a:r>
              <a:rPr lang="en-US" altLang="zh-CN" sz="1400" b="1" cap="all" dirty="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</a:t>
            </a:r>
            <a:r>
              <a:rPr lang="en-US" altLang="zh-CN" sz="14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S1 | </a:t>
            </a:r>
            <a:r>
              <a:rPr lang="en-US" altLang="zh-CN" sz="1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ompressive force curve in ten randomly selected sugarcane samples. </a:t>
            </a:r>
            <a:endParaRPr lang="zh-CN" altLang="en-US" sz="1400" dirty="0"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custDataLst>
              <p:tags r:id="rId1"/>
            </p:custDataLst>
          </p:nvPr>
        </p:nvGraphicFramePr>
        <p:xfrm>
          <a:off x="309489" y="1655203"/>
          <a:ext cx="11525212" cy="1282033"/>
        </p:xfrm>
        <a:graphic>
          <a:graphicData uri="http://schemas.openxmlformats.org/drawingml/2006/table">
            <a:tbl>
              <a:tblPr/>
              <a:tblGrid>
                <a:gridCol w="107514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87813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5797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36664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8768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5868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50714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002167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68112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457705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769306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606435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268112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479423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911182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521681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</a:tblGrid>
              <a:tr h="337932">
                <a:tc rowSpan="2">
                  <a:txBody>
                    <a:bodyPr/>
                    <a:lstStyle/>
                    <a:p>
                      <a:pPr algn="ctr" fontAlgn="ctr"/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CM</a:t>
                      </a: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ank</a:t>
                      </a: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pectrum range (cm</a:t>
                      </a:r>
                      <a:r>
                        <a:rPr lang="en-US" sz="14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in</a:t>
                      </a: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ax</a:t>
                      </a: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ean ± SD</a:t>
                      </a: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alibration</a:t>
                      </a:r>
                      <a:r>
                        <a:rPr lang="zh-CN" alt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ross validation</a:t>
                      </a: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08393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1400" b="1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400" b="1" i="1" baseline="-25000" dirty="0">
                          <a:solidFill>
                            <a:srgbClr val="000000"/>
                          </a:solidFill>
                          <a:effectLst/>
                          <a:uFillTx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</a:t>
                      </a: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MSEC</a:t>
                      </a: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PD</a:t>
                      </a: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altLang="zh-CN" sz="1400" b="1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altLang="zh-CN" sz="1400" b="1" i="1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v</a:t>
                      </a:r>
                      <a:endParaRPr lang="en-US" altLang="zh-CN" sz="1400" b="1" i="1" u="none" strike="noStrike" baseline="30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MSECV</a:t>
                      </a: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PD</a:t>
                      </a: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635708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S (</a:t>
                      </a:r>
                      <a:r>
                        <a:rPr lang="en-US" altLang="zh-CN" sz="14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N</a:t>
                      </a: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SP</a:t>
                      </a: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5669.7-6464.2, 7251.1-8045.6, 8824.7-9626.9, 10406-11987.4 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15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89</a:t>
                      </a:r>
                      <a:endParaRPr lang="zh-CN" altLang="en-US" sz="1400"/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136</a:t>
                      </a:r>
                      <a:endParaRPr lang="zh-CN" altLang="en-US" sz="1400" dirty="0"/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436 ± 0.28</a:t>
                      </a:r>
                      <a:endParaRPr lang="zh-CN" altLang="en-US" sz="1400"/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  <a:endParaRPr lang="zh-CN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2 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8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宋体" panose="02010600030101010101" pitchFamily="2" charset="-122"/>
                          <a:ea typeface="宋体" panose="02010600030101010101" pitchFamily="2" charset="-122"/>
                        </a:rPr>
                        <a:t>3.63</a:t>
                      </a: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  <a:endParaRPr lang="zh-CN" altLang="en-US" sz="1400" b="0" i="0" u="none" strike="noStrike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0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9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.1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宋体" panose="02010600030101010101" pitchFamily="2" charset="-122"/>
                        <a:ea typeface="宋体" panose="02010600030101010101" pitchFamily="2" charset="-122"/>
                      </a:endParaRPr>
                    </a:p>
                  </a:txBody>
                  <a:tcPr marL="4650" marR="4650" marT="465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197433" y="1346172"/>
            <a:ext cx="11553048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cap="all" dirty="0"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able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8 |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s of optimal equations for prediction of SCS (</a:t>
            </a:r>
            <a:r>
              <a:rPr lang="en-US" altLang="zh-CN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kN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sugarcane samples.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197433" y="3021043"/>
            <a:ext cx="11725718" cy="7372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SCS, stalk crushing strength;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M, scatter correction methods; N, samples number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；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,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imum value; Max,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ximum value; SD, standard deviation; </a:t>
            </a:r>
            <a:r>
              <a:rPr lang="en-US" altLang="zh-CN" sz="1400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</a:t>
            </a:r>
            <a:r>
              <a:rPr lang="en-US" altLang="zh-CN" sz="1400" i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400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rmination coefficient of calibration;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MSEC, root mean square error of calibration;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PD,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io performance deviation; </a:t>
            </a:r>
            <a:r>
              <a:rPr lang="en-US" altLang="zh-CN" sz="1400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</a:t>
            </a:r>
            <a:r>
              <a:rPr lang="en-US" altLang="zh-CN" sz="1400" i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400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v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rmination coefficient of cross validation; RMSECV, root mean square error of cross validation; 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NSP, n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o spectral preprement</a:t>
            </a:r>
            <a:r>
              <a:rPr lang="en-US" altLang="zh-CN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.</a:t>
            </a:r>
            <a:endParaRPr lang="en-US" altLang="zh-CN" sz="1400" dirty="0">
              <a:solidFill>
                <a:srgbClr val="000000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576047" y="1364475"/>
            <a:ext cx="9097487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cap="all" dirty="0"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able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9 |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s of the model-based 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</a:t>
            </a:r>
            <a:r>
              <a:rPr lang="en-US" altLang="zh-CN" sz="1400" b="0" i="0" dirty="0">
                <a:solidFill>
                  <a:srgbClr val="000000"/>
                </a:solidFill>
                <a:latin typeface="Times New Roman" panose="02020603050405020304" pitchFamily="18" charset="0"/>
                <a:ea typeface="等线" panose="02010600030101010101" pitchFamily="2" charset="-122"/>
              </a:rPr>
              <a:t>talk crushing strength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ediction results in sugarcane population.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1673938" y="5520014"/>
            <a:ext cx="8317424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, samples number; SD, standard deviation; CV, coefficient of variation.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表格 4"/>
          <p:cNvGraphicFramePr>
            <a:graphicFrameLocks noGrp="1"/>
          </p:cNvGraphicFramePr>
          <p:nvPr>
            <p:custDataLst>
              <p:tags r:id="rId1"/>
            </p:custDataLst>
          </p:nvPr>
        </p:nvGraphicFramePr>
        <p:xfrm>
          <a:off x="1673938" y="1676450"/>
          <a:ext cx="9251468" cy="3830955"/>
        </p:xfrm>
        <a:graphic>
          <a:graphicData uri="http://schemas.openxmlformats.org/drawingml/2006/table">
            <a:tbl>
              <a:tblPr/>
              <a:tblGrid>
                <a:gridCol w="76978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1285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6978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6072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36378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8742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93214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9939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457200"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Year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Plots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  <a:sym typeface="+mn-ea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N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Stalk crushing strength (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kN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84175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Mean ± S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CV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Outlier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Percentage of outliers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4635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0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3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276-1.84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189 ± 0.2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8%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54635">
                <a:tc>
                  <a:txBody>
                    <a:bodyPr/>
                    <a:lstStyle/>
                    <a:p>
                      <a:pPr algn="ctr" fontAlgn="b"/>
                      <a:endParaRPr lang="zh-CN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sym typeface="+mn-ea"/>
                        </a:rPr>
                        <a:t>336</a:t>
                      </a:r>
                      <a:endParaRPr lang="en-US" altLang="zh-CN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0.038-1.71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024 ± 0.2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23%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54682">
                <a:tc>
                  <a:txBody>
                    <a:bodyPr/>
                    <a:lstStyle/>
                    <a:p>
                      <a:pPr algn="ctr" fontAlgn="b"/>
                      <a:endParaRPr lang="zh-CN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sym typeface="+mn-ea"/>
                        </a:rPr>
                        <a:t>336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0.480-1.60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902 ± 0.3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3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7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92%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54682">
                <a:tc>
                  <a:txBody>
                    <a:bodyPr/>
                    <a:lstStyle/>
                    <a:p>
                      <a:pPr algn="ctr" fontAlgn="b"/>
                      <a:endParaRPr lang="zh-CN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71780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0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sym typeface="+mn-ea"/>
                        </a:rPr>
                        <a:t>336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0.140-1.82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209 ± 0.3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95%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54635">
                <a:tc>
                  <a:txBody>
                    <a:bodyPr/>
                    <a:lstStyle/>
                    <a:p>
                      <a:pPr algn="ctr" fontAlgn="b"/>
                      <a:endParaRPr lang="zh-CN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sym typeface="+mn-ea"/>
                        </a:rPr>
                        <a:t>336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761-2.36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577 ± 0.3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7%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54682">
                <a:tc>
                  <a:txBody>
                    <a:bodyPr/>
                    <a:lstStyle/>
                    <a:p>
                      <a:pPr algn="ctr" fontAlgn="b"/>
                      <a:endParaRPr lang="zh-CN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sym typeface="+mn-ea"/>
                        </a:rPr>
                        <a:t>336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730-2.30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412 ± 0.2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1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%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54682">
                <a:tc>
                  <a:txBody>
                    <a:bodyPr/>
                    <a:lstStyle/>
                    <a:p>
                      <a:pPr algn="ctr" fontAlgn="b"/>
                      <a:endParaRPr lang="zh-CN" altLang="en-US" sz="14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4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4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4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4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4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400" b="0" i="0" u="none" strike="noStrike">
                        <a:solidFill>
                          <a:srgbClr val="000000"/>
                        </a:solidFill>
                        <a:effectLst/>
                        <a:latin typeface="等线" panose="02010600030101010101" pitchFamily="2" charset="-122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>
                        <a:buNone/>
                      </a:pP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54682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02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sym typeface="+mn-ea"/>
                        </a:rPr>
                        <a:t>336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770-2.09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489 ± 0.2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1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0%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54682">
                <a:tc>
                  <a:txBody>
                    <a:bodyPr/>
                    <a:lstStyle/>
                    <a:p>
                      <a:pPr algn="ctr" fontAlgn="b"/>
                      <a:endParaRPr lang="zh-CN" altLang="en-US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sym typeface="+mn-ea"/>
                        </a:rPr>
                        <a:t>336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423-2.05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319 ± 0.2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1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%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54682"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　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  <a:sym typeface="+mn-ea"/>
                        </a:rPr>
                        <a:t>336</a:t>
                      </a:r>
                      <a:endParaRPr lang="en-US" altLang="zh-CN" sz="14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等线" panose="02010600030101010101" pitchFamily="2" charset="-122"/>
                      </a:endParaRP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-0.289-2.01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1.256 ± 0.3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0.2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等线" panose="02010600030101010101" pitchFamily="2" charset="-122"/>
                        </a:rPr>
                        <a:t>2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95%</a:t>
                      </a:r>
                      <a:endParaRPr lang="en-US" altLang="en-US" sz="1400" b="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/>
          <p:cNvGraphicFramePr>
            <a:graphicFrameLocks noChangeAspect="1"/>
          </p:cNvGraphicFramePr>
          <p:nvPr>
            <p:custDataLst>
              <p:tags r:id="rId1"/>
            </p:custDataLst>
          </p:nvPr>
        </p:nvGraphicFramePr>
        <p:xfrm>
          <a:off x="2224088" y="666750"/>
          <a:ext cx="8337550" cy="39141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4" imgW="9172575" imgH="4352925" progId="Prism8.Document">
                  <p:embed/>
                </p:oleObj>
              </mc:Choice>
              <mc:Fallback>
                <p:oleObj name="Prism 8" r:id="rId4" imgW="9172575" imgH="4352925" progId="Prism8.Document">
                  <p:embed/>
                  <p:pic>
                    <p:nvPicPr>
                      <p:cNvPr id="0" name="对象 3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224088" y="666750"/>
                        <a:ext cx="8337550" cy="3914140"/>
                      </a:xfrm>
                      <a:prstGeom prst="rect">
                        <a:avLst/>
                      </a:prstGeom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文本框 3"/>
          <p:cNvSpPr txBox="1"/>
          <p:nvPr>
            <p:custDataLst>
              <p:tags r:id="rId2"/>
            </p:custDataLst>
          </p:nvPr>
        </p:nvSpPr>
        <p:spPr>
          <a:xfrm>
            <a:off x="2404110" y="4704080"/>
            <a:ext cx="7897495" cy="737235"/>
          </a:xfrm>
          <a:prstGeom prst="rect">
            <a:avLst/>
          </a:prstGeom>
          <a:noFill/>
        </p:spPr>
        <p:txBody>
          <a:bodyPr wrap="square" rtlCol="0" anchor="t">
            <a:spAutoFit/>
          </a:bodyPr>
          <a:lstStyle/>
          <a:p>
            <a:pPr algn="just"/>
            <a:r>
              <a:rPr lang="en-US" altLang="zh-CN" sz="1400" b="1" cap="all" dirty="0">
                <a:solidFill>
                  <a:schemeClr val="tx1"/>
                </a:solidFill>
                <a:uFillTx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</a:t>
            </a:r>
            <a:r>
              <a:rPr lang="en-US" altLang="zh-CN" sz="1400" b="1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S2 | </a:t>
            </a:r>
            <a:r>
              <a:rPr lang="en-US" altLang="zh-CN" sz="1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chematic diagram of compressive force in two groups of ten representative sugarcane genotypes. H1-H5 and L1-L5 represented five sugarcane samples with high (H) and low (L) mechanical strength, respectively. Each sample contained three biological replicates.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1303971" y="190460"/>
            <a:ext cx="8938493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cap="all" dirty="0">
                <a:solidFill>
                  <a:schemeClr val="tx1"/>
                </a:solidFill>
                <a:uFillTx/>
                <a:latin typeface="Times New Roman" panose="02020603050405020304" pitchFamily="18" charset="0"/>
                <a:cs typeface="Times New Roman" panose="02020603050405020304" pitchFamily="18" charset="0"/>
              </a:rPr>
              <a:t>Table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1 |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eak statistics in the compression force curves of sugarcane stalks.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1299467" y="6495360"/>
            <a:ext cx="893849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1-R3, three biological replicates ; RSD, relative standard deviation.</a:t>
            </a:r>
          </a:p>
        </p:txBody>
      </p:sp>
      <p:graphicFrame>
        <p:nvGraphicFramePr>
          <p:cNvPr id="2" name="表格 1"/>
          <p:cNvGraphicFramePr>
            <a:graphicFrameLocks noGrp="1"/>
          </p:cNvGraphicFramePr>
          <p:nvPr>
            <p:custDataLst>
              <p:tags r:id="rId1"/>
            </p:custDataLst>
          </p:nvPr>
        </p:nvGraphicFramePr>
        <p:xfrm>
          <a:off x="1389082" y="523222"/>
          <a:ext cx="8992720" cy="5945400"/>
        </p:xfrm>
        <a:graphic>
          <a:graphicData uri="http://schemas.openxmlformats.org/drawingml/2006/table">
            <a:tbl>
              <a:tblPr/>
              <a:tblGrid>
                <a:gridCol w="7918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0744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792000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957432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eak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ompression force (</a:t>
                      </a:r>
                      <a:r>
                        <a:rPr lang="en-US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kN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SD (%)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ompression force (</a:t>
                      </a:r>
                      <a:r>
                        <a:rPr lang="en-US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kN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SD (%)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1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2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3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1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2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3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6-084</a:t>
                      </a:r>
                      <a:r>
                        <a:rPr lang="zh-CN" alt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05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121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105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.31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FG3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477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461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546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.0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en-US" altLang="zh-C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168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137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36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.98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848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444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4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2.48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168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298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300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.03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819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519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4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.20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497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306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3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4.1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53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805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865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.10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50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670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59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7.94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844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945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995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.99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60930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257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24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194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67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2-17204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074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146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070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.90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226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541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269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2.70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246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35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316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.13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501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583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600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.39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278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41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284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.71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426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566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95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1.67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59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561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31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.31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61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90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859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7.27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619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87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540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.34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G24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44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389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374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55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6-112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699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56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13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54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563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443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.23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815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204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85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2.08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803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76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455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1.54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92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167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961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.53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813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109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390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0.41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074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54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23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.43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077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383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873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2.16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100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547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481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.16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4-4316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224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294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261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78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6-167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396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358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304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.4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115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344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267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9.77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9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488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423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2.57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224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610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493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2.11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67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574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576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.76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9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29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68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555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1.38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824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647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519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.21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477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45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68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0.84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5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404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868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7.3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G39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221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155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148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85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YZ89-7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127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057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09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.21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2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655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42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323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.91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14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357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135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.4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3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97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266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331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5.47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408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45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321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.78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4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.289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242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300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2.54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470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657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615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.21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5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.640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480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447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3.79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68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720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079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.50 </a:t>
                      </a:r>
                    </a:p>
                  </a:txBody>
                  <a:tcPr marL="6840" marR="6840" marT="684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26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custDataLst>
              <p:tags r:id="rId1"/>
            </p:custDataLst>
          </p:nvPr>
        </p:nvGraphicFramePr>
        <p:xfrm>
          <a:off x="2160099" y="2269537"/>
          <a:ext cx="7712868" cy="2133651"/>
        </p:xfrm>
        <a:graphic>
          <a:graphicData uri="http://schemas.openxmlformats.org/drawingml/2006/table">
            <a:tbl>
              <a:tblPr/>
              <a:tblGrid>
                <a:gridCol w="1294479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0140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33643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0768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519311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53551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839652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lots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ample </a:t>
                      </a:r>
                    </a:p>
                    <a:p>
                      <a:pPr algn="ctr" fontAlgn="ctr"/>
                      <a:r>
                        <a:rPr lang="en-US" altLang="zh-C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umber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lant height</a:t>
                      </a:r>
                    </a:p>
                    <a:p>
                      <a:pPr algn="ctr" fontAlgn="ctr"/>
                      <a:r>
                        <a:rPr lang="en-US" altLang="zh-C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cm)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Internode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length</a:t>
                      </a:r>
                    </a:p>
                    <a:p>
                      <a:pPr algn="ctr" fontAlgn="ctr"/>
                      <a:r>
                        <a:rPr lang="en-US" altLang="zh-C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cm)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talk diameter</a:t>
                      </a:r>
                    </a:p>
                    <a:p>
                      <a:pPr algn="ctr" fontAlgn="ctr"/>
                      <a:r>
                        <a:rPr lang="en-US" altLang="zh-C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mm)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umber of internodes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3133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06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94-395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7.8-21.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7.67-37.47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6-35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3133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06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49-394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7.4-20.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0.22-40.82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5-35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3133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06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75-419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.8-19.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9.29-42.99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3-33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2145585" y="1962626"/>
            <a:ext cx="4895855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cap="all" dirty="0"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able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2 |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s of phenotype in sugarcane germplasm.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custDataLst>
              <p:tags r:id="rId1"/>
            </p:custDataLst>
          </p:nvPr>
        </p:nvGraphicFramePr>
        <p:xfrm>
          <a:off x="2829616" y="2165755"/>
          <a:ext cx="6730930" cy="1922804"/>
        </p:xfrm>
        <a:graphic>
          <a:graphicData uri="http://schemas.openxmlformats.org/drawingml/2006/table">
            <a:tbl>
              <a:tblPr/>
              <a:tblGrid>
                <a:gridCol w="129344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7492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923227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95015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01146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93483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42883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48070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Plots</a:t>
                      </a:r>
                      <a:endParaRPr lang="en-US" altLang="zh-C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in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ax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Mean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D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V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8070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06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81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833 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441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7 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5 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8070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06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89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720 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486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4 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3 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80701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06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61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572 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501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5 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3 </a:t>
                      </a:r>
                    </a:p>
                  </a:txBody>
                  <a:tcPr marL="7212" marR="7212" marT="7212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2730100" y="1867782"/>
            <a:ext cx="6760829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cap="all" dirty="0"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able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3 |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s of stalk crushing strength in sugarcane germplasm.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2856121" y="4135831"/>
            <a:ext cx="6152276" cy="52322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, samples number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；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,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imum value; Max,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ximum value; SD, standard deviation; CV, coefficient of variation.</a:t>
            </a:r>
            <a:endParaRPr lang="zh-CN" alt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custDataLst>
              <p:tags r:id="rId1"/>
            </p:custDataLst>
          </p:nvPr>
        </p:nvGraphicFramePr>
        <p:xfrm>
          <a:off x="2496118" y="2339704"/>
          <a:ext cx="7199763" cy="1873793"/>
        </p:xfrm>
        <a:graphic>
          <a:graphicData uri="http://schemas.openxmlformats.org/drawingml/2006/table">
            <a:tbl>
              <a:tblPr/>
              <a:tblGrid>
                <a:gridCol w="100431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29447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5447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3462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2827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1176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</a:tblGrid>
              <a:tr h="737390"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1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Plots</a:t>
                      </a:r>
                      <a:endParaRPr lang="en-US" altLang="zh-CN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lant height</a:t>
                      </a:r>
                    </a:p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cm)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Intern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ode length</a:t>
                      </a:r>
                    </a:p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cm)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talk diameter</a:t>
                      </a:r>
                    </a:p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(mm)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umber of </a:t>
                      </a:r>
                      <a:r>
                        <a:rPr lang="en-US" altLang="zh-C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internode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88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CS (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kN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46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0.341*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80*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23*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88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CS (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kN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64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0.446*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48*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412*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880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CS (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kN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0.005</a:t>
                      </a:r>
                    </a:p>
                  </a:txBody>
                  <a:tcPr marL="7731" marR="7731" marT="773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0.363*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03*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334***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2453914" y="2040143"/>
            <a:ext cx="8938493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cap="all" dirty="0"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able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4 |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rrelation analysis between stalk crushing strength and phenotype in sugarcane germplasm.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2453913" y="4257356"/>
            <a:ext cx="8938493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*** indicate significant correlation at </a:t>
            </a:r>
            <a:r>
              <a:rPr lang="en-US" altLang="zh-CN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1 level. SCS,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lk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rushing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rength.</a:t>
            </a: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custDataLst>
              <p:tags r:id="rId1"/>
            </p:custDataLst>
          </p:nvPr>
        </p:nvGraphicFramePr>
        <p:xfrm>
          <a:off x="2686052" y="1583740"/>
          <a:ext cx="5995870" cy="3565290"/>
        </p:xfrm>
        <a:graphic>
          <a:graphicData uri="http://schemas.openxmlformats.org/drawingml/2006/table">
            <a:tbl>
              <a:tblPr/>
              <a:tblGrid>
                <a:gridCol w="154354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03028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912258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50977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55455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rincipal </a:t>
                      </a:r>
                    </a:p>
                    <a:p>
                      <a:pPr algn="ctr" fontAlgn="ctr"/>
                      <a:r>
                        <a:rPr lang="en-US" altLang="zh-C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omponent</a:t>
                      </a:r>
                      <a:r>
                        <a:rPr lang="en-US" altLang="zh-C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 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Eigenvalue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Percentage of </a:t>
                      </a:r>
                    </a:p>
                    <a:p>
                      <a:pPr algn="ctr" fontAlgn="ctr"/>
                      <a:r>
                        <a:rPr lang="en-US" altLang="zh-CN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v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ariance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umulative (%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010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49.71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.98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2.98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010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0.53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70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7.68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010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45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41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09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010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4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1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5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44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010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15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65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010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60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6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81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010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9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4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85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3010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0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3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88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010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1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2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90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301074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5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1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indent="0" algn="ctr">
                        <a:buNone/>
                      </a:pPr>
                      <a:r>
                        <a:rPr lang="en-US" sz="1400" b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9.91 </a:t>
                      </a:r>
                      <a:endParaRPr lang="en-US" altLang="en-US" sz="1400" b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12700" marR="12700" marT="1270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</a:tbl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2587156" y="1281534"/>
            <a:ext cx="6643931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cap="all" dirty="0"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able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5 |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sult statistics of principal component analysis of NIRS data.</a:t>
            </a: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表格 2"/>
          <p:cNvGraphicFramePr>
            <a:graphicFrameLocks noGrp="1"/>
          </p:cNvGraphicFramePr>
          <p:nvPr>
            <p:custDataLst>
              <p:tags r:id="rId1"/>
            </p:custDataLst>
          </p:nvPr>
        </p:nvGraphicFramePr>
        <p:xfrm>
          <a:off x="1443501" y="2273542"/>
          <a:ext cx="9435505" cy="1468466"/>
        </p:xfrm>
        <a:graphic>
          <a:graphicData uri="http://schemas.openxmlformats.org/drawingml/2006/table">
            <a:tbl>
              <a:tblPr/>
              <a:tblGrid>
                <a:gridCol w="114563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2037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1182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1192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1192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11928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42926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605081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6193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826599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711928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711928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711928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663230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</a:tblGrid>
              <a:tr h="369043"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7">
                  <a:txBody>
                    <a:bodyPr/>
                    <a:lstStyle/>
                    <a:p>
                      <a:pPr algn="ctr" rtl="0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alibration 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 rtl="0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  External validation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69043">
                <a:tc>
                  <a:txBody>
                    <a:bodyPr/>
                    <a:lstStyle/>
                    <a:p>
                      <a:pPr algn="ctr" fontAlgn="ctr"/>
                      <a:endParaRPr lang="zh-CN" alt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宋体" panose="02010600030101010101" pitchFamily="2" charset="-122"/>
                      </a:endParaRP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in 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ax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ean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SD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V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N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in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ax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Mean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SD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CV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730380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SCS (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kN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)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62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689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136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439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8 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9 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</a:rPr>
                        <a:t>　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73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723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088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.446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28 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9</a:t>
                      </a:r>
                    </a:p>
                  </a:txBody>
                  <a:tcPr marL="5200" marR="5200" marT="5200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4" name="文本框 3"/>
          <p:cNvSpPr txBox="1"/>
          <p:nvPr/>
        </p:nvSpPr>
        <p:spPr>
          <a:xfrm>
            <a:off x="1338580" y="1909445"/>
            <a:ext cx="9540875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cap="all" dirty="0"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able</a:t>
            </a:r>
            <a:r>
              <a:rPr lang="en-US" altLang="zh-CN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6 |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s of stalk crushing strength of sugarcane samples in calibration and validation sets.</a:t>
            </a:r>
          </a:p>
        </p:txBody>
      </p:sp>
      <p:sp>
        <p:nvSpPr>
          <p:cNvPr id="5" name="文本框 4"/>
          <p:cNvSpPr txBox="1"/>
          <p:nvPr/>
        </p:nvSpPr>
        <p:spPr>
          <a:xfrm>
            <a:off x="1338702" y="3742008"/>
            <a:ext cx="10749355" cy="33855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, samples number; Min,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inimum value; Max,</a:t>
            </a:r>
            <a:r>
              <a:rPr lang="zh-CN" altLang="en-US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ximum value; SD, standard deviation; CV, coefficient of variation.</a:t>
            </a:r>
            <a:endParaRPr lang="zh-CN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格 1"/>
          <p:cNvGraphicFramePr>
            <a:graphicFrameLocks noGrp="1"/>
          </p:cNvGraphicFramePr>
          <p:nvPr>
            <p:custDataLst>
              <p:tags r:id="rId1"/>
            </p:custDataLst>
          </p:nvPr>
        </p:nvGraphicFramePr>
        <p:xfrm>
          <a:off x="239151" y="1603373"/>
          <a:ext cx="11248570" cy="1370358"/>
        </p:xfrm>
        <a:graphic>
          <a:graphicData uri="http://schemas.openxmlformats.org/drawingml/2006/table">
            <a:tbl>
              <a:tblPr/>
              <a:tblGrid>
                <a:gridCol w="97394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97394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8177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38379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384967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68719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04643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523911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212116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512235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834834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  <a:gridCol w="441798">
                  <a:extLst>
                    <a:ext uri="{9D8B030D-6E8A-4147-A177-3AD203B41FA5}">
                      <a16:colId xmlns:a16="http://schemas.microsoft.com/office/drawing/2014/main" val="20011"/>
                    </a:ext>
                  </a:extLst>
                </a:gridCol>
                <a:gridCol w="212116">
                  <a:extLst>
                    <a:ext uri="{9D8B030D-6E8A-4147-A177-3AD203B41FA5}">
                      <a16:colId xmlns:a16="http://schemas.microsoft.com/office/drawing/2014/main" val="20012"/>
                    </a:ext>
                  </a:extLst>
                </a:gridCol>
                <a:gridCol w="349459">
                  <a:extLst>
                    <a:ext uri="{9D8B030D-6E8A-4147-A177-3AD203B41FA5}">
                      <a16:colId xmlns:a16="http://schemas.microsoft.com/office/drawing/2014/main" val="20013"/>
                    </a:ext>
                  </a:extLst>
                </a:gridCol>
                <a:gridCol w="497661">
                  <a:extLst>
                    <a:ext uri="{9D8B030D-6E8A-4147-A177-3AD203B41FA5}">
                      <a16:colId xmlns:a16="http://schemas.microsoft.com/office/drawing/2014/main" val="20014"/>
                    </a:ext>
                  </a:extLst>
                </a:gridCol>
                <a:gridCol w="683748">
                  <a:extLst>
                    <a:ext uri="{9D8B030D-6E8A-4147-A177-3AD203B41FA5}">
                      <a16:colId xmlns:a16="http://schemas.microsoft.com/office/drawing/2014/main" val="20015"/>
                    </a:ext>
                  </a:extLst>
                </a:gridCol>
                <a:gridCol w="608900">
                  <a:extLst>
                    <a:ext uri="{9D8B030D-6E8A-4147-A177-3AD203B41FA5}">
                      <a16:colId xmlns:a16="http://schemas.microsoft.com/office/drawing/2014/main" val="20016"/>
                    </a:ext>
                  </a:extLst>
                </a:gridCol>
              </a:tblGrid>
              <a:tr h="382270">
                <a:tc rowSpan="2">
                  <a:txBody>
                    <a:bodyPr/>
                    <a:lstStyle/>
                    <a:p>
                      <a:pPr algn="ctr" fontAlgn="ctr"/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CM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ank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Spectrum range (cm</a:t>
                      </a:r>
                      <a:r>
                        <a:rPr lang="en-US" sz="1400" b="1" i="0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-1</a:t>
                      </a:r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)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alibration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ross validation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External validation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 w="12700" cmpd="sng">
                      <a:noFill/>
                      <a:prstDash val="soli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2745"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1400" b="1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400" b="1" i="1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</a:t>
                      </a:r>
                      <a:endParaRPr lang="en-US" sz="1400" b="1" i="1" u="none" strike="noStrike" baseline="30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MSEC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PD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1400" b="1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400" b="1" i="1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cv</a:t>
                      </a:r>
                      <a:endParaRPr lang="en-US" sz="1400" b="1" i="1" u="none" strike="noStrike" baseline="30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MSECV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PD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</a:t>
                      </a:r>
                      <a:r>
                        <a:rPr lang="en-US" sz="1400" b="1" i="1" u="none" strike="noStrike" baseline="30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US" sz="1400" b="1" i="1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ev</a:t>
                      </a:r>
                      <a:endParaRPr lang="en-US" sz="1400" b="1" i="1" u="none" strike="noStrike" baseline="300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MSEP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RPD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615343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CS (</a:t>
                      </a:r>
                      <a:r>
                        <a:rPr lang="en-US" altLang="zh-CN" sz="1400" dirty="0" err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N</a:t>
                      </a:r>
                      <a:r>
                        <a:rPr lang="en-US" altLang="zh-CN" sz="14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 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NSP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8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  <a:sym typeface="+mn-ea"/>
                        </a:rPr>
                        <a:t>5669.7-6464.2, 7251.1-8045.6, 8824.7-9626.9, </a:t>
                      </a:r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10406-11987.4   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62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92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8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.58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9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09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3.06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zh-CN" alt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　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73</a:t>
                      </a:r>
                      <a:endParaRPr lang="en-US" altLang="zh-CN" sz="16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宋体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83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0.11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CN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Times New Roman" panose="02020603050405020304" pitchFamily="18" charset="0"/>
                        </a:rPr>
                        <a:t>2.45</a:t>
                      </a:r>
                    </a:p>
                  </a:txBody>
                  <a:tcPr marL="4289" marR="4289" marT="4289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3" name="文本框 2"/>
          <p:cNvSpPr txBox="1"/>
          <p:nvPr/>
        </p:nvSpPr>
        <p:spPr>
          <a:xfrm>
            <a:off x="179949" y="1283353"/>
            <a:ext cx="11248570" cy="3067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cap="all" dirty="0">
                <a:uFillTx/>
                <a:latin typeface="Times New Roman" panose="02020603050405020304" pitchFamily="18" charset="0"/>
                <a:cs typeface="Times New Roman" panose="02020603050405020304" pitchFamily="18" charset="0"/>
                <a:sym typeface="+mn-ea"/>
              </a:rPr>
              <a:t>Table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7 |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s of calibration and validation parameters for equations for </a:t>
            </a:r>
            <a:r>
              <a:rPr lang="en-US" altLang="zh-CN" sz="1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stalk crushing strength modeling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179949" y="3111795"/>
            <a:ext cx="11419133" cy="73723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400" dirty="0"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  <a:sym typeface="+mn-ea"/>
              </a:rPr>
              <a:t>SCS, stalk crushing strength;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M, scatter correction methods; N, samples number; </a:t>
            </a:r>
            <a:r>
              <a:rPr lang="en-US" altLang="zh-CN" sz="1400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</a:t>
            </a:r>
            <a:r>
              <a:rPr lang="en-US" altLang="zh-CN" sz="1400" i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400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rmination coefficient of calibration;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MSEC, root mean square error of calibration;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PD,</a:t>
            </a:r>
            <a:r>
              <a:rPr lang="zh-CN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atio performance deviation; </a:t>
            </a:r>
            <a:r>
              <a:rPr lang="en-US" altLang="zh-CN" sz="1400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</a:t>
            </a:r>
            <a:r>
              <a:rPr lang="en-US" altLang="zh-CN" sz="1400" i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400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cv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,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rmination coefficient of cross validation; RMSECV, root mean square error of cross validation; </a:t>
            </a:r>
            <a:r>
              <a:rPr lang="en-US" altLang="zh-CN" sz="1400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R</a:t>
            </a:r>
            <a:r>
              <a:rPr lang="en-US" altLang="zh-CN" sz="1400" i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2</a:t>
            </a:r>
            <a:r>
              <a:rPr lang="en-US" altLang="zh-CN" sz="1400" i="1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ev</a:t>
            </a:r>
            <a:r>
              <a:rPr lang="en-US" altLang="zh-CN" sz="1400" dirty="0">
                <a:solidFill>
                  <a:srgbClr val="000000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, 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rmination coefficient of external validation; </a:t>
            </a:r>
            <a:r>
              <a:rPr lang="en-US" altLang="zh-CN" sz="14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SP, n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 spectral preprement</a:t>
            </a:r>
            <a:r>
              <a:rPr lang="en-US" altLang="zh-CN" sz="1400" b="0" i="0" u="none" strike="noStrike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.</a:t>
            </a:r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61fce4a2-fbdc-42e0-aa2d-21a0643cb54f"/>
  <p:tag name="COMMONDATA" val="eyJoZGlkIjoiNzVmNjg1MTE5ZTcxN2NjMGIxZjE2NGFkODY2MDc1NzA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86e9fbe2-d5cc-4bab-9414-538933daec4f}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c87b8c64-3fd8-4bcc-809a-c1bb4780f90a}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912a1fd1-7f0c-47d0-b62a-8fbb13649296}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7dd7add7-5636-4ba3-9455-4b75cba20c82}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e9709e11-47e5-4ae6-a853-39ca318377b2}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5bef8b12-a55c-43bc-8cb8-edfacb3142a4}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1a3d0823-3c54-4b3e-848c-b6be57331004}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b8181174-abb0-459c-9eac-c98217ae02ee}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TABLE_BEAUTIFY" val="smartTable{b6c1c81c-59b8-4787-9d8e-5c0589486736}"/>
</p:tagLst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133</Words>
  <Application>Microsoft Office PowerPoint</Application>
  <PresentationFormat>宽屏</PresentationFormat>
  <Paragraphs>580</Paragraphs>
  <Slides>11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11</vt:i4>
      </vt:variant>
    </vt:vector>
  </HeadingPairs>
  <TitlesOfParts>
    <vt:vector size="18" baseType="lpstr">
      <vt:lpstr>等线</vt:lpstr>
      <vt:lpstr>等线 Light</vt:lpstr>
      <vt:lpstr>宋体</vt:lpstr>
      <vt:lpstr>Arial</vt:lpstr>
      <vt:lpstr>Times New Roman</vt:lpstr>
      <vt:lpstr>Office 主题​​</vt:lpstr>
      <vt:lpstr>Prism 8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istrator</dc:creator>
  <cp:lastModifiedBy>Huang JF</cp:lastModifiedBy>
  <cp:revision>105</cp:revision>
  <dcterms:created xsi:type="dcterms:W3CDTF">2022-08-19T13:34:00Z</dcterms:created>
  <dcterms:modified xsi:type="dcterms:W3CDTF">2023-06-29T10:02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502BBD38A841456099408CEC3F921C08</vt:lpwstr>
  </property>
  <property fmtid="{D5CDD505-2E9C-101B-9397-08002B2CF9AE}" pid="3" name="KSOProductBuildVer">
    <vt:lpwstr>2052-11.1.0.14309</vt:lpwstr>
  </property>
</Properties>
</file>